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95D0029-B068-E7E3-8434-E0A468D6B83B}" name="Daisy Recchia" initials="DR" userId="f133eb4f7c8129a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83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E5C33-224B-B26F-4A71-BC852B4B8C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E8AC51-A9AC-66CC-98F9-A42A024E0D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7A39E-6A31-5119-8909-4E2BA5E11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84CD49-FA02-B2B0-9853-CC9E6A6A0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147631-B164-1505-5D70-B4D695DB5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5027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5B017-9CC0-BCB2-8AAC-9FE576B5A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27FF09-4620-F3C4-F651-CCB27FA217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45986-C82B-F369-618A-050116A5D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FDBBDB-C1DD-15CC-45DE-BA7088369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DD0176-F5F4-3F02-226B-5B4EBD796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16508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D6D55E-4FF5-ADFB-AC78-3B860A9EAD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F56F91-CCB7-927D-2DDF-888B921848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F7767-3786-F3F6-16C7-B157DFE77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454E63-F233-C5AE-82CD-51076AD01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16836-D40D-E4D6-BBF7-DAE99D4C4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0746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E1FBD-BDF8-4B04-3C54-EB60CC4A0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A3D30F-6FCE-CE5A-7CB5-F413D6CAEA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1E7CEB-4E28-04C5-0B97-14517ECFF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A5F382-F96E-4DC5-A2E1-F324F9544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B5A28-9001-2F0E-5871-DD725558C6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9949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F4E0C-7872-D2EB-9A1B-558A535BEA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2A3904-3CEB-9A59-DD49-389F9B3AE4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EC17C-7C75-6F08-5FF4-BBDCA700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13C336-CC61-55EE-FC66-0B0A74F2F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44B66-D7E8-948B-A229-6EAA0880F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1713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82EDDF-0515-9C84-1AB7-7AE4BAF294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AD8F13-6362-4A1C-2A90-8982712CF7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7E6982-B70B-C96D-FD5E-EA82CB1F1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08877-3D6D-37EE-D44F-6DC7C0478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5EAA76-4482-C260-3C97-A84AECAC8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810645-5D45-126F-73EF-19006B753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5921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B9F8F-5AF4-8C6E-F60E-2C537D0C57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4CEDD5-3AF6-3A06-9D9A-0078223ADA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C4F7DB-F34D-FC75-CFDE-3B7D3C4567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055D2E-96F4-EA69-3DC1-6537332517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DBD420-6B26-7B23-0F5B-D1461CBE34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F400B0-31F2-AD8E-5869-0BE65437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F75FC11-3144-97D2-8A8F-9F8E928FD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41D15C-D57D-7345-E871-A69AEA82C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7189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974DD-6B61-2655-34CB-3BFA5A4E1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446981-452D-E103-BF75-8854AE28E1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26BD99-B7C0-3F0B-1733-912538916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4EBB63-043B-3202-FE74-29A59DDFB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0156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C882EC-5E5F-D82C-203F-DCEE41D75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48FF2C-9864-BBDA-F3BB-3D8660753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0740B3-136D-3988-DF8A-EA00600FA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971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DCF37-B432-653D-425B-6F6BAE418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1D6B7A-D430-B454-4549-E2DFD58138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5C30BA-4F30-ABE8-37DF-F18E70FD5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23B1FD-0723-ED85-C01E-B6563CFCF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9FB0B1-9F0E-8A82-943A-00C4C81C2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B47831-6A8F-F2C8-8E66-3668D387D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5206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22DEE-E727-0992-BB1E-2D4428A04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BAD774-5550-5FBB-8417-F7243595E0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C15700-BC09-91E5-78E2-284221A64B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62ED6C-FE97-0ED1-2958-2FE418128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476794-4C20-93D5-0142-83ECE9143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D90308-D380-5441-516E-E21A57AF3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2869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B438B6-31C6-F2B9-2E3F-D6D68900A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CAD3CE-8F8A-3D55-7FB9-C163F891B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C24AE-009F-EBCF-0DEA-A187BD107F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3461A-105D-427B-978A-99E0A447EBE5}" type="datetimeFigureOut">
              <a:rPr lang="en-US" smtClean="0"/>
              <a:t>11/25/2024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7615D-4C65-8631-8CF2-A77C2FED51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6F31FD-FCC7-7321-FC87-4B037BFC45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44C1D-0E02-41C5-A011-F3A1F77335B9}" type="slidenum">
              <a:rPr lang="en-US" smtClean="0"/>
              <a:t>‹N°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7333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ZoneTexte 27"/>
          <p:cNvSpPr txBox="1"/>
          <p:nvPr/>
        </p:nvSpPr>
        <p:spPr>
          <a:xfrm>
            <a:off x="347096" y="326370"/>
            <a:ext cx="8786393" cy="261610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Figure S1.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 Design and Flow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t diagram mapping the selection of participants 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347096" y="979814"/>
            <a:ext cx="1649869" cy="261610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Study Design  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8172049" y="979814"/>
            <a:ext cx="3694130" cy="261610"/>
          </a:xfrm>
          <a:prstGeom prst="rect">
            <a:avLst/>
          </a:prstGeom>
          <a:solidFill>
            <a:srgbClr val="FFFF00"/>
          </a:solidFill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low chart mapping the selection of participants 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5" name="Image 5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014" y="1395155"/>
            <a:ext cx="7431344" cy="2282163"/>
          </a:xfrm>
          <a:prstGeom prst="rect">
            <a:avLst/>
          </a:prstGeom>
        </p:spPr>
      </p:pic>
      <p:sp>
        <p:nvSpPr>
          <p:cNvPr id="57" name="Rectangle 56"/>
          <p:cNvSpPr/>
          <p:nvPr/>
        </p:nvSpPr>
        <p:spPr>
          <a:xfrm>
            <a:off x="263014" y="3831049"/>
            <a:ext cx="692606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all these phases, participants were self-administered a health questionnaire and a clinical examination took place.</a:t>
            </a:r>
          </a:p>
        </p:txBody>
      </p:sp>
      <p:pic>
        <p:nvPicPr>
          <p:cNvPr id="73" name="Image 7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77609" y="1566188"/>
            <a:ext cx="3935169" cy="4077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3861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9028" y="1444954"/>
            <a:ext cx="3074558" cy="4146946"/>
          </a:xfrm>
          <a:prstGeom prst="rect">
            <a:avLst/>
          </a:prstGeom>
        </p:spPr>
      </p:pic>
      <p:grpSp>
        <p:nvGrpSpPr>
          <p:cNvPr id="4" name="Groupe 3"/>
          <p:cNvGrpSpPr/>
          <p:nvPr/>
        </p:nvGrpSpPr>
        <p:grpSpPr>
          <a:xfrm>
            <a:off x="3135939" y="1668269"/>
            <a:ext cx="2602595" cy="3700316"/>
            <a:chOff x="2526339" y="1264158"/>
            <a:chExt cx="2602595" cy="3700316"/>
          </a:xfrm>
        </p:grpSpPr>
        <p:sp>
          <p:nvSpPr>
            <p:cNvPr id="5" name="ZoneTexte 44">
              <a:extLst>
                <a:ext uri="{FF2B5EF4-FFF2-40B4-BE49-F238E27FC236}">
                  <a16:creationId xmlns:a16="http://schemas.microsoft.com/office/drawing/2014/main" id="{3C771353-F6B3-4A31-91DB-A2F73A8EA589}"/>
                </a:ext>
              </a:extLst>
            </p:cNvPr>
            <p:cNvSpPr txBox="1"/>
            <p:nvPr/>
          </p:nvSpPr>
          <p:spPr>
            <a:xfrm>
              <a:off x="2526339" y="1525693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1</a:t>
              </a:r>
            </a:p>
          </p:txBody>
        </p:sp>
        <p:sp>
          <p:nvSpPr>
            <p:cNvPr id="6" name="ZoneTexte 53">
              <a:extLst>
                <a:ext uri="{FF2B5EF4-FFF2-40B4-BE49-F238E27FC236}">
                  <a16:creationId xmlns:a16="http://schemas.microsoft.com/office/drawing/2014/main" id="{00E87C4B-5998-4A7F-AB86-A669F9101D18}"/>
                </a:ext>
              </a:extLst>
            </p:cNvPr>
            <p:cNvSpPr txBox="1"/>
            <p:nvPr/>
          </p:nvSpPr>
          <p:spPr>
            <a:xfrm>
              <a:off x="2526339" y="2873651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2</a:t>
              </a:r>
            </a:p>
          </p:txBody>
        </p:sp>
        <p:sp>
          <p:nvSpPr>
            <p:cNvPr id="7" name="ZoneTexte 54">
              <a:extLst>
                <a:ext uri="{FF2B5EF4-FFF2-40B4-BE49-F238E27FC236}">
                  <a16:creationId xmlns:a16="http://schemas.microsoft.com/office/drawing/2014/main" id="{0E3F48C7-E6B8-461B-AE06-158AA93D80B5}"/>
                </a:ext>
              </a:extLst>
            </p:cNvPr>
            <p:cNvSpPr txBox="1"/>
            <p:nvPr/>
          </p:nvSpPr>
          <p:spPr>
            <a:xfrm>
              <a:off x="2526339" y="4201189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del 3</a:t>
              </a:r>
            </a:p>
          </p:txBody>
        </p:sp>
        <p:sp>
          <p:nvSpPr>
            <p:cNvPr id="8" name="ZoneTexte 39">
              <a:extLst>
                <a:ext uri="{FF2B5EF4-FFF2-40B4-BE49-F238E27FC236}">
                  <a16:creationId xmlns:a16="http://schemas.microsoft.com/office/drawing/2014/main" id="{A0C79688-666C-4383-933F-12641891F3D7}"/>
                </a:ext>
              </a:extLst>
            </p:cNvPr>
            <p:cNvSpPr txBox="1"/>
            <p:nvPr/>
          </p:nvSpPr>
          <p:spPr>
            <a:xfrm>
              <a:off x="3809057" y="1264158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1</a:t>
              </a:r>
            </a:p>
          </p:txBody>
        </p:sp>
        <p:sp>
          <p:nvSpPr>
            <p:cNvPr id="9" name="ZoneTexte 40">
              <a:extLst>
                <a:ext uri="{FF2B5EF4-FFF2-40B4-BE49-F238E27FC236}">
                  <a16:creationId xmlns:a16="http://schemas.microsoft.com/office/drawing/2014/main" id="{72E4269D-7B2E-436F-B0B1-3706196B165E}"/>
                </a:ext>
              </a:extLst>
            </p:cNvPr>
            <p:cNvSpPr txBox="1"/>
            <p:nvPr/>
          </p:nvSpPr>
          <p:spPr>
            <a:xfrm>
              <a:off x="3802440" y="1610022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2</a:t>
              </a:r>
            </a:p>
          </p:txBody>
        </p:sp>
        <p:sp>
          <p:nvSpPr>
            <p:cNvPr id="10" name="ZoneTexte 41">
              <a:extLst>
                <a:ext uri="{FF2B5EF4-FFF2-40B4-BE49-F238E27FC236}">
                  <a16:creationId xmlns:a16="http://schemas.microsoft.com/office/drawing/2014/main" id="{8953C491-068A-458D-A14D-A1D78D2F367D}"/>
                </a:ext>
              </a:extLst>
            </p:cNvPr>
            <p:cNvSpPr txBox="1"/>
            <p:nvPr/>
          </p:nvSpPr>
          <p:spPr>
            <a:xfrm>
              <a:off x="3809057" y="1957044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3</a:t>
              </a:r>
            </a:p>
          </p:txBody>
        </p:sp>
        <p:sp>
          <p:nvSpPr>
            <p:cNvPr id="11" name="ZoneTexte 39">
              <a:extLst>
                <a:ext uri="{FF2B5EF4-FFF2-40B4-BE49-F238E27FC236}">
                  <a16:creationId xmlns:a16="http://schemas.microsoft.com/office/drawing/2014/main" id="{8864C107-FA25-4456-9B6A-72E9B3FBFD4E}"/>
                </a:ext>
              </a:extLst>
            </p:cNvPr>
            <p:cNvSpPr txBox="1"/>
            <p:nvPr/>
          </p:nvSpPr>
          <p:spPr>
            <a:xfrm>
              <a:off x="3809057" y="2684514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1</a:t>
              </a:r>
            </a:p>
          </p:txBody>
        </p:sp>
        <p:sp>
          <p:nvSpPr>
            <p:cNvPr id="12" name="ZoneTexte 40">
              <a:extLst>
                <a:ext uri="{FF2B5EF4-FFF2-40B4-BE49-F238E27FC236}">
                  <a16:creationId xmlns:a16="http://schemas.microsoft.com/office/drawing/2014/main" id="{0B77145E-A32F-41D0-B4D8-09B9F6AD82E6}"/>
                </a:ext>
              </a:extLst>
            </p:cNvPr>
            <p:cNvSpPr txBox="1"/>
            <p:nvPr/>
          </p:nvSpPr>
          <p:spPr>
            <a:xfrm>
              <a:off x="3820880" y="3030803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2</a:t>
              </a:r>
            </a:p>
          </p:txBody>
        </p:sp>
        <p:sp>
          <p:nvSpPr>
            <p:cNvPr id="13" name="ZoneTexte 41">
              <a:extLst>
                <a:ext uri="{FF2B5EF4-FFF2-40B4-BE49-F238E27FC236}">
                  <a16:creationId xmlns:a16="http://schemas.microsoft.com/office/drawing/2014/main" id="{32729EC1-FD03-49EA-A002-C9CEA1624DA6}"/>
                </a:ext>
              </a:extLst>
            </p:cNvPr>
            <p:cNvSpPr txBox="1"/>
            <p:nvPr/>
          </p:nvSpPr>
          <p:spPr>
            <a:xfrm>
              <a:off x="3827497" y="3377825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3</a:t>
              </a:r>
            </a:p>
          </p:txBody>
        </p:sp>
        <p:sp>
          <p:nvSpPr>
            <p:cNvPr id="14" name="ZoneTexte 39">
              <a:extLst>
                <a:ext uri="{FF2B5EF4-FFF2-40B4-BE49-F238E27FC236}">
                  <a16:creationId xmlns:a16="http://schemas.microsoft.com/office/drawing/2014/main" id="{75D44AA5-849D-49AB-9EAD-3AD8670AE5AE}"/>
                </a:ext>
              </a:extLst>
            </p:cNvPr>
            <p:cNvSpPr txBox="1"/>
            <p:nvPr/>
          </p:nvSpPr>
          <p:spPr>
            <a:xfrm>
              <a:off x="3814350" y="4024942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1</a:t>
              </a:r>
            </a:p>
          </p:txBody>
        </p:sp>
        <p:sp>
          <p:nvSpPr>
            <p:cNvPr id="15" name="ZoneTexte 40">
              <a:extLst>
                <a:ext uri="{FF2B5EF4-FFF2-40B4-BE49-F238E27FC236}">
                  <a16:creationId xmlns:a16="http://schemas.microsoft.com/office/drawing/2014/main" id="{56C6A7EB-AEAB-4C7C-BC98-69A920F478DB}"/>
                </a:ext>
              </a:extLst>
            </p:cNvPr>
            <p:cNvSpPr txBox="1"/>
            <p:nvPr/>
          </p:nvSpPr>
          <p:spPr>
            <a:xfrm>
              <a:off x="3826173" y="4371231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2</a:t>
              </a:r>
            </a:p>
          </p:txBody>
        </p:sp>
        <p:sp>
          <p:nvSpPr>
            <p:cNvPr id="16" name="ZoneTexte 41">
              <a:extLst>
                <a:ext uri="{FF2B5EF4-FFF2-40B4-BE49-F238E27FC236}">
                  <a16:creationId xmlns:a16="http://schemas.microsoft.com/office/drawing/2014/main" id="{751B2CCD-9F29-4B27-8F2D-904FC377C4C5}"/>
                </a:ext>
              </a:extLst>
            </p:cNvPr>
            <p:cNvSpPr txBox="1"/>
            <p:nvPr/>
          </p:nvSpPr>
          <p:spPr>
            <a:xfrm>
              <a:off x="3832790" y="4718253"/>
              <a:ext cx="1296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fr-FR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rtile 3</a:t>
              </a:r>
            </a:p>
          </p:txBody>
        </p:sp>
      </p:grpSp>
      <p:sp>
        <p:nvSpPr>
          <p:cNvPr id="17" name="ZoneTexte 36">
            <a:extLst>
              <a:ext uri="{FF2B5EF4-FFF2-40B4-BE49-F238E27FC236}">
                <a16:creationId xmlns:a16="http://schemas.microsoft.com/office/drawing/2014/main" id="{27C4DA3A-CF8D-40EE-A2AE-CD238D7CC7DE}"/>
              </a:ext>
            </a:extLst>
          </p:cNvPr>
          <p:cNvSpPr txBox="1"/>
          <p:nvPr/>
        </p:nvSpPr>
        <p:spPr>
          <a:xfrm>
            <a:off x="600075" y="1330000"/>
            <a:ext cx="343415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ND Diet Score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E70DE-4AC0-497C-A58E-7C279F316FB4}"/>
              </a:ext>
            </a:extLst>
          </p:cNvPr>
          <p:cNvSpPr/>
          <p:nvPr/>
        </p:nvSpPr>
        <p:spPr>
          <a:xfrm>
            <a:off x="4539028" y="1206211"/>
            <a:ext cx="3260885" cy="26161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dds Ratio of recurrent depressive symptoms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ZoneTexte 57">
            <a:extLst>
              <a:ext uri="{FF2B5EF4-FFF2-40B4-BE49-F238E27FC236}">
                <a16:creationId xmlns:a16="http://schemas.microsoft.com/office/drawing/2014/main" id="{361A0A87-469B-4CBF-9CD6-C4E6260A6DB5}"/>
              </a:ext>
            </a:extLst>
          </p:cNvPr>
          <p:cNvSpPr txBox="1"/>
          <p:nvPr/>
        </p:nvSpPr>
        <p:spPr>
          <a:xfrm>
            <a:off x="6871423" y="1891315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3 (0.59; 0,90)</a:t>
            </a:r>
          </a:p>
        </p:txBody>
      </p:sp>
      <p:sp>
        <p:nvSpPr>
          <p:cNvPr id="21" name="ZoneTexte 58">
            <a:extLst>
              <a:ext uri="{FF2B5EF4-FFF2-40B4-BE49-F238E27FC236}">
                <a16:creationId xmlns:a16="http://schemas.microsoft.com/office/drawing/2014/main" id="{E2EA9C15-678A-48B7-A947-232CB40320C9}"/>
              </a:ext>
            </a:extLst>
          </p:cNvPr>
          <p:cNvSpPr txBox="1"/>
          <p:nvPr/>
        </p:nvSpPr>
        <p:spPr>
          <a:xfrm>
            <a:off x="6875339" y="2223786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1 (0.58; 0.88)</a:t>
            </a:r>
          </a:p>
        </p:txBody>
      </p:sp>
      <p:sp>
        <p:nvSpPr>
          <p:cNvPr id="23" name="ZoneTexte 57">
            <a:extLst>
              <a:ext uri="{FF2B5EF4-FFF2-40B4-BE49-F238E27FC236}">
                <a16:creationId xmlns:a16="http://schemas.microsoft.com/office/drawing/2014/main" id="{AA5C777E-4811-447D-91E0-5C7AC985ACA0}"/>
              </a:ext>
            </a:extLst>
          </p:cNvPr>
          <p:cNvSpPr txBox="1"/>
          <p:nvPr/>
        </p:nvSpPr>
        <p:spPr>
          <a:xfrm>
            <a:off x="6920880" y="3377313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9 (0.64; 0,98)</a:t>
            </a:r>
          </a:p>
        </p:txBody>
      </p:sp>
      <p:sp>
        <p:nvSpPr>
          <p:cNvPr id="24" name="ZoneTexte 58">
            <a:extLst>
              <a:ext uri="{FF2B5EF4-FFF2-40B4-BE49-F238E27FC236}">
                <a16:creationId xmlns:a16="http://schemas.microsoft.com/office/drawing/2014/main" id="{65E9FF22-8FCE-4F7F-B798-52122FD170BF}"/>
              </a:ext>
            </a:extLst>
          </p:cNvPr>
          <p:cNvSpPr txBox="1"/>
          <p:nvPr/>
        </p:nvSpPr>
        <p:spPr>
          <a:xfrm>
            <a:off x="6924796" y="3709784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78 (0.62; 0.97)</a:t>
            </a:r>
          </a:p>
        </p:txBody>
      </p:sp>
      <p:sp>
        <p:nvSpPr>
          <p:cNvPr id="26" name="ZoneTexte 57">
            <a:extLst>
              <a:ext uri="{FF2B5EF4-FFF2-40B4-BE49-F238E27FC236}">
                <a16:creationId xmlns:a16="http://schemas.microsoft.com/office/drawing/2014/main" id="{9BBE203D-4B80-4E2C-A9D7-867C52F30138}"/>
              </a:ext>
            </a:extLst>
          </p:cNvPr>
          <p:cNvSpPr txBox="1"/>
          <p:nvPr/>
        </p:nvSpPr>
        <p:spPr>
          <a:xfrm>
            <a:off x="6920880" y="4735149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0 (0.64;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7" name="ZoneTexte 58">
            <a:extLst>
              <a:ext uri="{FF2B5EF4-FFF2-40B4-BE49-F238E27FC236}">
                <a16:creationId xmlns:a16="http://schemas.microsoft.com/office/drawing/2014/main" id="{404CC4A4-8B76-4D49-9B89-9C29D519CD9A}"/>
              </a:ext>
            </a:extLst>
          </p:cNvPr>
          <p:cNvSpPr txBox="1"/>
          <p:nvPr/>
        </p:nvSpPr>
        <p:spPr>
          <a:xfrm>
            <a:off x="6924796" y="5067620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2 (0.65; 1,03)</a:t>
            </a:r>
          </a:p>
        </p:txBody>
      </p:sp>
      <p:sp>
        <p:nvSpPr>
          <p:cNvPr id="28" name="ZoneTexte 56">
            <a:extLst>
              <a:ext uri="{FF2B5EF4-FFF2-40B4-BE49-F238E27FC236}">
                <a16:creationId xmlns:a16="http://schemas.microsoft.com/office/drawing/2014/main" id="{B8D51F00-F74C-47CD-9F98-B40D05AEA4A3}"/>
              </a:ext>
            </a:extLst>
          </p:cNvPr>
          <p:cNvSpPr txBox="1"/>
          <p:nvPr/>
        </p:nvSpPr>
        <p:spPr>
          <a:xfrm>
            <a:off x="6863860" y="1590941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 (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9" name="ZoneTexte 56">
            <a:extLst>
              <a:ext uri="{FF2B5EF4-FFF2-40B4-BE49-F238E27FC236}">
                <a16:creationId xmlns:a16="http://schemas.microsoft.com/office/drawing/2014/main" id="{7F98108D-3F6B-4A24-8F85-92B3A3B7F389}"/>
              </a:ext>
            </a:extLst>
          </p:cNvPr>
          <p:cNvSpPr txBox="1"/>
          <p:nvPr/>
        </p:nvSpPr>
        <p:spPr>
          <a:xfrm>
            <a:off x="6913317" y="3076939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 (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0" name="ZoneTexte 56">
            <a:extLst>
              <a:ext uri="{FF2B5EF4-FFF2-40B4-BE49-F238E27FC236}">
                <a16:creationId xmlns:a16="http://schemas.microsoft.com/office/drawing/2014/main" id="{815D00DC-C1F1-4BD6-B0E8-8963ECE34AA7}"/>
              </a:ext>
            </a:extLst>
          </p:cNvPr>
          <p:cNvSpPr txBox="1"/>
          <p:nvPr/>
        </p:nvSpPr>
        <p:spPr>
          <a:xfrm>
            <a:off x="6920880" y="4434775"/>
            <a:ext cx="1296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0 (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erenc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47C134B4-C794-4B3E-8FDE-A8B8CAE6F7AA}"/>
              </a:ext>
            </a:extLst>
          </p:cNvPr>
          <p:cNvSpPr txBox="1"/>
          <p:nvPr/>
        </p:nvSpPr>
        <p:spPr>
          <a:xfrm>
            <a:off x="4650793" y="5475467"/>
            <a:ext cx="3397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/>
              <a:t>        0.2    0.4   0.6    0.8     1     1.2    1.4    1.6    1.8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3EB8A64D-F695-4B93-BD2B-2BBE00D9354F}"/>
              </a:ext>
            </a:extLst>
          </p:cNvPr>
          <p:cNvSpPr txBox="1"/>
          <p:nvPr/>
        </p:nvSpPr>
        <p:spPr>
          <a:xfrm>
            <a:off x="757237" y="194669"/>
            <a:ext cx="1018222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Figure S2. Association between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cumulative average of MIND diet score over 11-year of exposure period (1991/93 – 2002/04) and recurrence of depressive </a:t>
            </a:r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symptoms </a:t>
            </a:r>
            <a:r>
              <a:rPr lang="en-GB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 years of follow-up in 4824 Whitehall II participants (3526 men and 1298 women) .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36" name="ZoneTexte 43">
            <a:extLst>
              <a:ext uri="{FF2B5EF4-FFF2-40B4-BE49-F238E27FC236}">
                <a16:creationId xmlns:a16="http://schemas.microsoft.com/office/drawing/2014/main" id="{008C5615-F5CE-4FF6-A4AF-276D3AE452AC}"/>
              </a:ext>
            </a:extLst>
          </p:cNvPr>
          <p:cNvSpPr txBox="1"/>
          <p:nvPr/>
        </p:nvSpPr>
        <p:spPr>
          <a:xfrm>
            <a:off x="1619250" y="5785060"/>
            <a:ext cx="9982200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1 adjusted for :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, age and cumulative average score of total energy intake</a:t>
            </a:r>
          </a:p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2 adjusted for : M1 +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hnicity, marital status, socio-economic status, education level, smoking status, alcohol consumption and physical activity assessed in 1991/93</a:t>
            </a:r>
          </a:p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3 adjusted for : M2 +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onary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hypertension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iabetes,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slipidemia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dy mass index,  </a:t>
            </a:r>
            <a:r>
              <a:rPr lang="fr-F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ecedents</a:t>
            </a:r>
            <a:r>
              <a:rPr lang="fr-F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ressive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mptom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ssed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1991/93</a:t>
            </a:r>
          </a:p>
        </p:txBody>
      </p:sp>
    </p:spTree>
    <p:extLst>
      <p:ext uri="{BB962C8B-B14F-4D97-AF65-F5344CB8AC3E}">
        <p14:creationId xmlns:p14="http://schemas.microsoft.com/office/powerpoint/2010/main" val="4251996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1</TotalTime>
  <Words>260</Words>
  <Application>Microsoft Office PowerPoint</Application>
  <PresentationFormat>Grand écran</PresentationFormat>
  <Paragraphs>3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Husnain Arshad</dc:creator>
  <cp:lastModifiedBy>AKBARALY</cp:lastModifiedBy>
  <cp:revision>49</cp:revision>
  <dcterms:created xsi:type="dcterms:W3CDTF">2022-05-30T15:09:54Z</dcterms:created>
  <dcterms:modified xsi:type="dcterms:W3CDTF">2024-11-25T16:58:14Z</dcterms:modified>
</cp:coreProperties>
</file>